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7" roundtripDataSignature="AMtx7mjhAWo9JTJvKld+0NOzPppkbfzoT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251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-182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21" Type="http://schemas.openxmlformats.org/officeDocument/2006/relationships/tableStyles" Target="tableStyles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1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uster of sprouts with green lines&#10;&#10;Description automatically generated">
            <a:extLst>
              <a:ext uri="{FF2B5EF4-FFF2-40B4-BE49-F238E27FC236}">
                <a16:creationId xmlns:a16="http://schemas.microsoft.com/office/drawing/2014/main" id="{92165E4E-FBBC-4293-A2D8-6073B7AA73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039" y="955002"/>
            <a:ext cx="4915922" cy="32459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D95D26-EE9B-41F5-874E-D2E0481F2B04}"/>
              </a:ext>
            </a:extLst>
          </p:cNvPr>
          <p:cNvSpPr txBox="1"/>
          <p:nvPr/>
        </p:nvSpPr>
        <p:spPr>
          <a:xfrm>
            <a:off x="851769" y="4310390"/>
            <a:ext cx="503519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inoa panicle divided into clusters, used as a reference for development of the PHS scoring scale.</a:t>
            </a:r>
            <a:endParaRPr lang="en-US" sz="10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971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2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Hauvermale, Amber Lynn</cp:lastModifiedBy>
  <cp:revision>43</cp:revision>
  <dcterms:created xsi:type="dcterms:W3CDTF">2021-03-09T22:22:12Z</dcterms:created>
  <dcterms:modified xsi:type="dcterms:W3CDTF">2024-03-15T01:24:18Z</dcterms:modified>
</cp:coreProperties>
</file>